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>
      <p:cViewPr varScale="1">
        <p:scale>
          <a:sx n="93" d="100"/>
          <a:sy n="93" d="100"/>
        </p:scale>
        <p:origin x="49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452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11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288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627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526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182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498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215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008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405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294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65126-2717-43B7-B307-F69F038F215E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6DAC5-7009-452C-B743-11BF55892D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661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0525" y="4057650"/>
            <a:ext cx="619830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Genetic characterization and genome-wide association mapping for dwarf bunt resistance in bread wheat accessions from the USDA National Small Grains Collection </a:t>
            </a:r>
            <a:endParaRPr lang="en-US" sz="1100" dirty="0" smtClean="0"/>
          </a:p>
          <a:p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le 3 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e-wid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kage disequilibrium (LD) scatter plot showing correlations (r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etwee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achromosom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NP marker pairs as a function of inter-marker physical position; a smoothing spline (black line) with lambda equal to 10,000 is fit to the data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526" y="372250"/>
            <a:ext cx="4572000" cy="34282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35296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don, Tyler</dc:creator>
  <cp:lastModifiedBy>Gordon, Tyler</cp:lastModifiedBy>
  <cp:revision>1</cp:revision>
  <dcterms:created xsi:type="dcterms:W3CDTF">2019-09-11T22:07:51Z</dcterms:created>
  <dcterms:modified xsi:type="dcterms:W3CDTF">2019-09-18T16:00:01Z</dcterms:modified>
</cp:coreProperties>
</file>